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8D089-3108-4943-8E47-2D2A7614C7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21956-A959-4752-B8AC-FE67AA24D5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75680-D17F-490A-97FA-F74D45AE77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5B7FE7-5BC6-411A-A720-70F50481BD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10724-E218-4AAE-917F-CEBCA07D35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BD898-BD12-478A-80BE-34147DEE16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8A8EAF-5EB0-4173-8FFA-A5D46E3175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56CD5A-CB39-438B-AD30-F5262A314F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F1306-17EE-48EA-A008-51A0DC6298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FAAC9-8045-4979-94C9-B73CFF3C52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2C641E-E5F8-4471-9804-A6FFE0ECE3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B7BCF-3D17-45FF-86A5-2021FA3D82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0AD36B-2835-4611-930C-2778709D0F4E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95280" y="1486080"/>
          <a:ext cx="7993080" cy="4535280"/>
        </p:xfrm>
        <a:graphic>
          <a:graphicData uri="http://schemas.openxmlformats.org/drawingml/2006/table">
            <a:tbl>
              <a:tblPr/>
              <a:tblGrid>
                <a:gridCol w="1279440"/>
                <a:gridCol w="1278000"/>
                <a:gridCol w="831960"/>
                <a:gridCol w="895320"/>
                <a:gridCol w="958680"/>
                <a:gridCol w="959040"/>
                <a:gridCol w="831960"/>
                <a:gridCol w="958680"/>
              </a:tblGrid>
              <a:tr h="404640">
                <a:tc rowSpan="2">
                  <a:txBody>
                    <a:bodyPr lIns="28080" rIns="28080" tIns="0" bIns="0" anchor="ctr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di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aramet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6"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Weeks of starvatio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25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74640">
                <a:tc rowSpan="2">
                  <a:txBody>
                    <a:bodyPr lIns="28080" rIns="28080" tIns="0" bIns="0" anchor="ctr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inuous ligh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(L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rotein/bioma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627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Chl a (nmol/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74640">
                <a:tc rowSpan="2">
                  <a:txBody>
                    <a:bodyPr lIns="28080" rIns="28080" tIns="0" bIns="0" anchor="ctr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inuous dar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(D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rotein/bioma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2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4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Chl a (nmol/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6360">
                <a:tc rowSpan="2">
                  <a:txBody>
                    <a:bodyPr lIns="28080" rIns="28080" tIns="0" bIns="0" anchor="ctr">
                      <a:noAutofit/>
                    </a:bodyPr>
                    <a:p>
                      <a:pPr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Light/dark cycle (L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rotein/bioma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0.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03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080" rIns="28080" tIns="0" bIns="0" anchor="ctr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Chl a (nmol/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080" marR="28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6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7"/>
          <p:cNvSpPr/>
          <p:nvPr/>
        </p:nvSpPr>
        <p:spPr>
          <a:xfrm>
            <a:off x="324000" y="549360"/>
            <a:ext cx="8273880" cy="82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ABLES1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tein/biomass and bacteriochlorophyll a concentration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Dinoroseobacter shiba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pon starvation under complex media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05T05:17:26Z</dcterms:created>
  <dc:creator>Maya</dc:creator>
  <dc:description/>
  <dc:language>en-US</dc:language>
  <cp:lastModifiedBy>ICBM</cp:lastModifiedBy>
  <dcterms:modified xsi:type="dcterms:W3CDTF">2013-11-22T11:09:18Z</dcterms:modified>
  <cp:revision>3</cp:revision>
  <dc:subject/>
  <dc:title>PowerPoint Presentation</dc:title>
</cp:coreProperties>
</file>